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56" r:id="rId2"/>
    <p:sldId id="257" r:id="rId3"/>
    <p:sldId id="258" r:id="rId4"/>
    <p:sldId id="259" r:id="rId5"/>
    <p:sldId id="260" r:id="rId6"/>
    <p:sldId id="261" r:id="rId7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00" autoAdjust="0"/>
    <p:restoredTop sz="94660"/>
  </p:normalViewPr>
  <p:slideViewPr>
    <p:cSldViewPr snapToGrid="0" showGuides="1">
      <p:cViewPr varScale="1">
        <p:scale>
          <a:sx n="78" d="100"/>
          <a:sy n="78" d="100"/>
        </p:scale>
        <p:origin x="3084" y="96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de-DE" smtClean="0"/>
              <a:t>Formatvorlage des Untertitelmasters durch Klicken bearbeite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852692-809D-472A-81E8-45056963662E}" type="datetimeFigureOut">
              <a:rPr lang="de-DE" smtClean="0"/>
              <a:t>18.08.2021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22013F-581C-4C4A-BA4F-6AB0B6649EAE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37857343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852692-809D-472A-81E8-45056963662E}" type="datetimeFigureOut">
              <a:rPr lang="de-DE" smtClean="0"/>
              <a:t>18.08.2021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22013F-581C-4C4A-BA4F-6AB0B6649EAE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73425054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852692-809D-472A-81E8-45056963662E}" type="datetimeFigureOut">
              <a:rPr lang="de-DE" smtClean="0"/>
              <a:t>18.08.2021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22013F-581C-4C4A-BA4F-6AB0B6649EAE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75699807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852692-809D-472A-81E8-45056963662E}" type="datetimeFigureOut">
              <a:rPr lang="de-DE" smtClean="0"/>
              <a:t>18.08.2021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22013F-581C-4C4A-BA4F-6AB0B6649EAE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39548735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852692-809D-472A-81E8-45056963662E}" type="datetimeFigureOut">
              <a:rPr lang="de-DE" smtClean="0"/>
              <a:t>18.08.2021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22013F-581C-4C4A-BA4F-6AB0B6649EAE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61374011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852692-809D-472A-81E8-45056963662E}" type="datetimeFigureOut">
              <a:rPr lang="de-DE" smtClean="0"/>
              <a:t>18.08.2021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22013F-581C-4C4A-BA4F-6AB0B6649EAE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10504181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852692-809D-472A-81E8-45056963662E}" type="datetimeFigureOut">
              <a:rPr lang="de-DE" smtClean="0"/>
              <a:t>18.08.2021</a:t>
            </a:fld>
            <a:endParaRPr lang="de-DE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22013F-581C-4C4A-BA4F-6AB0B6649EAE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64578479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852692-809D-472A-81E8-45056963662E}" type="datetimeFigureOut">
              <a:rPr lang="de-DE" smtClean="0"/>
              <a:t>18.08.2021</a:t>
            </a:fld>
            <a:endParaRPr lang="de-DE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22013F-581C-4C4A-BA4F-6AB0B6649EAE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02227509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852692-809D-472A-81E8-45056963662E}" type="datetimeFigureOut">
              <a:rPr lang="de-DE" smtClean="0"/>
              <a:t>18.08.2021</a:t>
            </a:fld>
            <a:endParaRPr lang="de-DE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22013F-581C-4C4A-BA4F-6AB0B6649EAE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58646743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852692-809D-472A-81E8-45056963662E}" type="datetimeFigureOut">
              <a:rPr lang="de-DE" smtClean="0"/>
              <a:t>18.08.2021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22013F-581C-4C4A-BA4F-6AB0B6649EAE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34672112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de-DE" smtClean="0"/>
              <a:t>Bild durch Klicken auf Symbol hinzufü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852692-809D-472A-81E8-45056963662E}" type="datetimeFigureOut">
              <a:rPr lang="de-DE" smtClean="0"/>
              <a:t>18.08.2021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22013F-581C-4C4A-BA4F-6AB0B6649EAE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61772466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D852692-809D-472A-81E8-45056963662E}" type="datetimeFigureOut">
              <a:rPr lang="de-DE" smtClean="0"/>
              <a:t>18.08.2021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F22013F-581C-4C4A-BA4F-6AB0B6649EAE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68949480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jpe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jpeg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jpeg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jpe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/>
        <p:txBody>
          <a:bodyPr/>
          <a:lstStyle/>
          <a:p>
            <a:r>
              <a:rPr lang="de-DE" dirty="0" err="1" smtClean="0"/>
              <a:t>Supplementary</a:t>
            </a:r>
            <a:r>
              <a:rPr lang="de-DE" dirty="0" smtClean="0"/>
              <a:t> </a:t>
            </a:r>
            <a:r>
              <a:rPr lang="de-DE" dirty="0" err="1"/>
              <a:t>F</a:t>
            </a:r>
            <a:r>
              <a:rPr lang="de-DE" dirty="0" err="1" smtClean="0"/>
              <a:t>igures</a:t>
            </a:r>
            <a:endParaRPr lang="de-DE" dirty="0"/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/>
        <p:txBody>
          <a:bodyPr/>
          <a:lstStyle/>
          <a:p>
            <a:r>
              <a:rPr lang="en-US" b="1" dirty="0"/>
              <a:t>Autoantibodies to </a:t>
            </a:r>
            <a:r>
              <a:rPr lang="en-US" b="1" dirty="0" err="1" smtClean="0"/>
              <a:t>Vasoregulative</a:t>
            </a:r>
            <a:r>
              <a:rPr lang="en-US" b="1" dirty="0" smtClean="0"/>
              <a:t> G-Protein Coupled Receptors Correlate With Symptom Severity</a:t>
            </a:r>
            <a:r>
              <a:rPr lang="en-US" b="1" dirty="0"/>
              <a:t>, </a:t>
            </a:r>
            <a:r>
              <a:rPr lang="en-US" b="1" dirty="0" smtClean="0"/>
              <a:t>Autonomic Dysfunction </a:t>
            </a:r>
            <a:r>
              <a:rPr lang="en-US" b="1" dirty="0"/>
              <a:t>and </a:t>
            </a:r>
            <a:r>
              <a:rPr lang="en-US" b="1" dirty="0" smtClean="0"/>
              <a:t>Disability </a:t>
            </a:r>
            <a:r>
              <a:rPr lang="en-US" b="1" dirty="0"/>
              <a:t>in </a:t>
            </a:r>
            <a:r>
              <a:rPr lang="en-US" b="1" dirty="0" err="1"/>
              <a:t>Myalgic</a:t>
            </a:r>
            <a:r>
              <a:rPr lang="en-US" b="1" dirty="0"/>
              <a:t> Encephalomyelitis / Chronic Fatigue Syndrome</a:t>
            </a:r>
            <a:endParaRPr lang="de-DE" b="1" dirty="0"/>
          </a:p>
          <a:p>
            <a:endParaRPr lang="de-DE" dirty="0"/>
          </a:p>
        </p:txBody>
      </p:sp>
    </p:spTree>
    <p:extLst>
      <p:ext uri="{BB962C8B-B14F-4D97-AF65-F5344CB8AC3E}">
        <p14:creationId xmlns:p14="http://schemas.microsoft.com/office/powerpoint/2010/main" val="29152655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Grafik 3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202980"/>
            <a:ext cx="6858000" cy="883277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7738092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Grafik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739330"/>
            <a:ext cx="6858000" cy="842734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5476490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Grafik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674008"/>
            <a:ext cx="6858000" cy="855798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24071451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Grafik 4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37071"/>
            <a:ext cx="6858000" cy="961206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52945018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Grafik 2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20235" b="7379"/>
          <a:stretch/>
        </p:blipFill>
        <p:spPr>
          <a:xfrm>
            <a:off x="0" y="111211"/>
            <a:ext cx="6858000" cy="621544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24675621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24</Words>
  <Application>Microsoft Office PowerPoint</Application>
  <PresentationFormat>A4-Papier (210 x 297 mm)</PresentationFormat>
  <Paragraphs>2</Paragraphs>
  <Slides>6</Slides>
  <Notes>0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3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6</vt:i4>
      </vt:variant>
    </vt:vector>
  </HeadingPairs>
  <TitlesOfParts>
    <vt:vector size="10" baseType="lpstr">
      <vt:lpstr>Arial</vt:lpstr>
      <vt:lpstr>Calibri</vt:lpstr>
      <vt:lpstr>Calibri Light</vt:lpstr>
      <vt:lpstr>Office</vt:lpstr>
      <vt:lpstr>Supplementary Figures</vt:lpstr>
      <vt:lpstr>PowerPoint-Präsentation</vt:lpstr>
      <vt:lpstr>PowerPoint-Präsentation</vt:lpstr>
      <vt:lpstr>PowerPoint-Präsentation</vt:lpstr>
      <vt:lpstr>PowerPoint-Präsentation</vt:lpstr>
      <vt:lpstr>PowerPoint-Präsentation</vt:lpstr>
    </vt:vector>
  </TitlesOfParts>
  <Company>Charité Universitaetsmedizin Berlin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upplementary Figures</dc:title>
  <dc:creator>Freitag, Helma</dc:creator>
  <cp:lastModifiedBy>Sotzny, Franziska</cp:lastModifiedBy>
  <cp:revision>9</cp:revision>
  <dcterms:created xsi:type="dcterms:W3CDTF">2021-07-05T13:09:30Z</dcterms:created>
  <dcterms:modified xsi:type="dcterms:W3CDTF">2021-08-18T08:48:49Z</dcterms:modified>
</cp:coreProperties>
</file>